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5196"/>
  </p:normalViewPr>
  <p:slideViewPr>
    <p:cSldViewPr snapToGrid="0" snapToObjects="1">
      <p:cViewPr varScale="1">
        <p:scale>
          <a:sx n="90" d="100"/>
          <a:sy n="90" d="100"/>
        </p:scale>
        <p:origin x="16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098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016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301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082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150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179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4080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051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075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2897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9528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6162D-91EF-B84A-9AAF-2F61168BA08B}" type="datetimeFigureOut">
              <a:rPr kumimoji="1" lang="ja-JP" altLang="en-US" smtClean="0"/>
              <a:t>2021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84298-D821-334B-8245-7C0C0E4A11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877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9B3A8D7-9A96-1547-B34B-CD9E4FBBB2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3634787"/>
              </p:ext>
            </p:extLst>
          </p:nvPr>
        </p:nvGraphicFramePr>
        <p:xfrm>
          <a:off x="735013" y="754063"/>
          <a:ext cx="8104185" cy="5372092"/>
        </p:xfrm>
        <a:graphic>
          <a:graphicData uri="http://schemas.openxmlformats.org/drawingml/2006/table">
            <a:tbl>
              <a:tblPr/>
              <a:tblGrid>
                <a:gridCol w="838653">
                  <a:extLst>
                    <a:ext uri="{9D8B030D-6E8A-4147-A177-3AD203B41FA5}">
                      <a16:colId xmlns:a16="http://schemas.microsoft.com/office/drawing/2014/main" val="4000577864"/>
                    </a:ext>
                  </a:extLst>
                </a:gridCol>
                <a:gridCol w="838653">
                  <a:extLst>
                    <a:ext uri="{9D8B030D-6E8A-4147-A177-3AD203B41FA5}">
                      <a16:colId xmlns:a16="http://schemas.microsoft.com/office/drawing/2014/main" val="3808776104"/>
                    </a:ext>
                  </a:extLst>
                </a:gridCol>
                <a:gridCol w="838653">
                  <a:extLst>
                    <a:ext uri="{9D8B030D-6E8A-4147-A177-3AD203B41FA5}">
                      <a16:colId xmlns:a16="http://schemas.microsoft.com/office/drawing/2014/main" val="1447182678"/>
                    </a:ext>
                  </a:extLst>
                </a:gridCol>
                <a:gridCol w="1232820">
                  <a:extLst>
                    <a:ext uri="{9D8B030D-6E8A-4147-A177-3AD203B41FA5}">
                      <a16:colId xmlns:a16="http://schemas.microsoft.com/office/drawing/2014/main" val="1227503055"/>
                    </a:ext>
                  </a:extLst>
                </a:gridCol>
                <a:gridCol w="1084658">
                  <a:extLst>
                    <a:ext uri="{9D8B030D-6E8A-4147-A177-3AD203B41FA5}">
                      <a16:colId xmlns:a16="http://schemas.microsoft.com/office/drawing/2014/main" val="649309229"/>
                    </a:ext>
                  </a:extLst>
                </a:gridCol>
                <a:gridCol w="1006384">
                  <a:extLst>
                    <a:ext uri="{9D8B030D-6E8A-4147-A177-3AD203B41FA5}">
                      <a16:colId xmlns:a16="http://schemas.microsoft.com/office/drawing/2014/main" val="1971455493"/>
                    </a:ext>
                  </a:extLst>
                </a:gridCol>
                <a:gridCol w="1065090">
                  <a:extLst>
                    <a:ext uri="{9D8B030D-6E8A-4147-A177-3AD203B41FA5}">
                      <a16:colId xmlns:a16="http://schemas.microsoft.com/office/drawing/2014/main" val="47024398"/>
                    </a:ext>
                  </a:extLst>
                </a:gridCol>
                <a:gridCol w="1199274">
                  <a:extLst>
                    <a:ext uri="{9D8B030D-6E8A-4147-A177-3AD203B41FA5}">
                      <a16:colId xmlns:a16="http://schemas.microsoft.com/office/drawing/2014/main" val="3162868901"/>
                    </a:ext>
                  </a:extLst>
                </a:gridCol>
              </a:tblGrid>
              <a:tr h="23255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Cell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PS1 genotype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Onset-age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  <a:ea typeface="游ゴシック" panose="020B0400000000000000" pitchFamily="34" charset="-128"/>
                        </a:rPr>
                        <a:t>b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8 (pM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  <a:ea typeface="游ゴシック" panose="020B0400000000000000" pitchFamily="34" charset="-128"/>
                        </a:rPr>
                        <a:t>b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0 (pM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  <a:ea typeface="游ゴシック" panose="020B0400000000000000" pitchFamily="34" charset="-128"/>
                        </a:rPr>
                        <a:t>b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2 (pM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Symbol" pitchFamily="2" charset="2"/>
                          <a:ea typeface="游ゴシック" panose="020B0400000000000000" pitchFamily="34" charset="-128"/>
                        </a:rPr>
                        <a:t>b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3 (pM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ICD (pM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0319137"/>
                  </a:ext>
                </a:extLst>
              </a:tr>
              <a:tr h="2441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(year-old)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0821261"/>
                  </a:ext>
                </a:extLst>
              </a:tr>
              <a:tr h="244187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CHO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WT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25.38±78.9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340.17±36.1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03.04±16.3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41.61±63.3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462.26±1332.4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8181452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C263F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26.58±35.3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04.52±4.2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88.86±15.8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53.30±9.8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975.94±159.6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082736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E273A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54.63±11.8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102.78±52.8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51.01±23.3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59.75±128.6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314.43±711.6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491751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79V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81.33±25.7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883.01±75.0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45.54±12.2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75.93±43.4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450.24±151.0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3118997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E123K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13.07±93.9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347.99±54.4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97.93±10.5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65.10±68.7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375.57±1659.9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4719931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A409T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68.26±26.0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103.78±73.1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87.94±25.2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70.76±120.3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266.68±650.7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7333744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E280A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7.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77.92±9.1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97.73±9.3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27.37±1.6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54.38±10.1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046.95±257.4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3755132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M233T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98.91±41.7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98.50±38.7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91.73±18.8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86.55±16.1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081.20±188.8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7884031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M146L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39.95±65.6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857.45±88.5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07.88±6.0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00.24±19.9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272.82±748.3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9513516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G384A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33.13±15.8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76.32±20.6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69.06±8.9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40.78±51.2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838.91±102.3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802585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I143T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51.32±33.7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53.35±30.4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20.20±21.0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62.09±11.12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383.50±194.5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7203105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L166P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3.55±7.2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65.53±22.9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7.89±8.0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12.18±147.2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930.73±390.5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5604261"/>
                  </a:ext>
                </a:extLst>
              </a:tr>
              <a:tr h="232558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HEK</a:t>
                      </a:r>
                    </a:p>
                  </a:txBody>
                  <a:tcPr marL="7347" marR="7347" marT="734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WT 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8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20.64±44.8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156.44±82.0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48.34±9.9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62.17±19.9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237.70±943.5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9595993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H163R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96.45±21.3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194.98±88.0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41.37±16.3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12.48±48.8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132.14±755.4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9973030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delE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3.55±11.7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10.78±31.6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7.28±21.9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08.46±10.9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934.57±722.9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4659314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I213T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63.59±8.6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731.04±24.2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93.15±8.6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93.69±31.6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915.83±49.0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7456280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L286V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7.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537.50±37.1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264.73±94.91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16.44±5.5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31.12±27.7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915.31±414.6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139921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M233L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57.26±10.4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984.11±99.2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72.27±20.3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03.19±6.43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430.39±1777.0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9433983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G206V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02.39±45.20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824.37±52.4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721.92±88.5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28.34±6.2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7256.93±1383.5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1679425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L381V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50.23±34.9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058.47±109.79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466.58±5.8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584.64±28.76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0113.72±671.5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7960763"/>
                  </a:ext>
                </a:extLst>
              </a:tr>
              <a:tr h="23255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L85P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2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66.38±5.25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60.97±9.1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75.27±8.24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365.34±12.97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  <a:ea typeface="游ゴシック" panose="020B0400000000000000" pitchFamily="34" charset="-128"/>
                        </a:rPr>
                        <a:t>1383.56±210.18</a:t>
                      </a:r>
                    </a:p>
                  </a:txBody>
                  <a:tcPr marL="7347" marR="7347" marT="734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054531"/>
                  </a:ext>
                </a:extLst>
              </a:tr>
            </a:tbl>
          </a:graphicData>
        </a:graphic>
      </p:graphicFrame>
      <p:sp>
        <p:nvSpPr>
          <p:cNvPr id="5" name="テキスト ボックス 8">
            <a:extLst>
              <a:ext uri="{FF2B5EF4-FFF2-40B4-BE49-F238E27FC236}">
                <a16:creationId xmlns:a16="http://schemas.microsoft.com/office/drawing/2014/main" id="{6FDE259F-D89E-E943-B5EE-C623221E8F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625" y="217488"/>
            <a:ext cx="1382713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2400" dirty="0">
                <a:latin typeface="Helvetica" pitchFamily="2" charset="0"/>
              </a:rPr>
              <a:t>Table S1</a:t>
            </a:r>
            <a:endParaRPr lang="ja-JP" altLang="en-US" sz="24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8522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8</Words>
  <Application>Microsoft Macintosh PowerPoint</Application>
  <PresentationFormat>画面に合わせる (4:3)</PresentationFormat>
  <Paragraphs>15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Helvetica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</cp:revision>
  <dcterms:created xsi:type="dcterms:W3CDTF">2021-10-15T03:42:29Z</dcterms:created>
  <dcterms:modified xsi:type="dcterms:W3CDTF">2021-10-15T03:43:27Z</dcterms:modified>
</cp:coreProperties>
</file>